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>
      <p:cViewPr varScale="1">
        <p:scale>
          <a:sx n="121" d="100"/>
          <a:sy n="121" d="100"/>
        </p:scale>
        <p:origin x="1904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r Wang" userId="0d40bd6fa3cc65da" providerId="LiveId" clId="{D3248243-FF19-4079-9E22-D598BB02F2EE}"/>
    <pc:docChg chg="custSel modSld">
      <pc:chgData name="Dr Wang" userId="0d40bd6fa3cc65da" providerId="LiveId" clId="{D3248243-FF19-4079-9E22-D598BB02F2EE}" dt="2025-11-06T05:06:06.088" v="3" actId="478"/>
      <pc:docMkLst>
        <pc:docMk/>
      </pc:docMkLst>
      <pc:sldChg chg="delSp modSp mod">
        <pc:chgData name="Dr Wang" userId="0d40bd6fa3cc65da" providerId="LiveId" clId="{D3248243-FF19-4079-9E22-D598BB02F2EE}" dt="2025-11-06T05:06:06.088" v="3" actId="478"/>
        <pc:sldMkLst>
          <pc:docMk/>
          <pc:sldMk cId="3494412282" sldId="256"/>
        </pc:sldMkLst>
        <pc:spChg chg="del">
          <ac:chgData name="Dr Wang" userId="0d40bd6fa3cc65da" providerId="LiveId" clId="{D3248243-FF19-4079-9E22-D598BB02F2EE}" dt="2025-11-06T05:06:06.088" v="3" actId="478"/>
          <ac:spMkLst>
            <pc:docMk/>
            <pc:sldMk cId="3494412282" sldId="256"/>
            <ac:spMk id="4" creationId="{00000000-0000-0000-0000-000000000000}"/>
          </ac:spMkLst>
        </pc:spChg>
        <pc:spChg chg="del mod">
          <ac:chgData name="Dr Wang" userId="0d40bd6fa3cc65da" providerId="LiveId" clId="{D3248243-FF19-4079-9E22-D598BB02F2EE}" dt="2025-11-06T05:06:03.497" v="2" actId="478"/>
          <ac:spMkLst>
            <pc:docMk/>
            <pc:sldMk cId="3494412282" sldId="256"/>
            <ac:spMk id="8" creationId="{00000000-0000-0000-0000-000000000000}"/>
          </ac:spMkLst>
        </pc:spChg>
        <pc:picChg chg="del">
          <ac:chgData name="Dr Wang" userId="0d40bd6fa3cc65da" providerId="LiveId" clId="{D3248243-FF19-4079-9E22-D598BB02F2EE}" dt="2025-11-06T05:05:59.243" v="0" actId="478"/>
          <ac:picMkLst>
            <pc:docMk/>
            <pc:sldMk cId="3494412282" sldId="256"/>
            <ac:picMk id="1027" creationId="{00000000-0000-0000-0000-00000000000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611560" y="681055"/>
            <a:ext cx="8020050" cy="13797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EFBD46AA-A7F0-D426-885B-A48400F73F85}"/>
              </a:ext>
            </a:extLst>
          </p:cNvPr>
          <p:cNvSpPr txBox="1"/>
          <p:nvPr/>
        </p:nvSpPr>
        <p:spPr>
          <a:xfrm>
            <a:off x="611560" y="2321004"/>
            <a:ext cx="835292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2. Effect of high-intensity interval training on the quality of life assessed by the Medical Outcomes Study Short-Form 36 general health survey (physical component) among surgical lung cancer patients.</a:t>
            </a:r>
            <a:endParaRPr lang="zh-CN" altLang="zh-CN" sz="16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94412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5</Words>
  <Application>Microsoft Macintosh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华西医院</dc:creator>
  <cp:lastModifiedBy>A7522</cp:lastModifiedBy>
  <cp:revision>3</cp:revision>
  <dcterms:created xsi:type="dcterms:W3CDTF">2025-11-05T07:49:03Z</dcterms:created>
  <dcterms:modified xsi:type="dcterms:W3CDTF">2026-03-13T03:33:52Z</dcterms:modified>
</cp:coreProperties>
</file>